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606" y="6319018"/>
            <a:ext cx="2700338" cy="2357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66" y="3510706"/>
            <a:ext cx="4014788" cy="2357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feld 12"/>
          <p:cNvSpPr txBox="1"/>
          <p:nvPr/>
        </p:nvSpPr>
        <p:spPr>
          <a:xfrm>
            <a:off x="252594" y="179398"/>
            <a:ext cx="63447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Fig.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7: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Infection of osteoblasts and endothelial cells with SH1000 and mutants over 9 days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09756" y="755576"/>
            <a:ext cx="2752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: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CFU/ml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during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infection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urse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51725" y="6042019"/>
            <a:ext cx="16642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: SCVs after 9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545490" y="651254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864357" y="4238640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566849" y="364620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233306" y="3300199"/>
            <a:ext cx="17924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CFU/ml after 9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6662" y="2031182"/>
            <a:ext cx="1298575" cy="2036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feld 20"/>
          <p:cNvSpPr txBox="1"/>
          <p:nvPr/>
        </p:nvSpPr>
        <p:spPr>
          <a:xfrm>
            <a:off x="5884814" y="2050232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WT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5890147" y="2804220"/>
            <a:ext cx="620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∆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sigB</a:t>
            </a:r>
            <a:endParaRPr lang="en-US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877272" y="3433242"/>
            <a:ext cx="11160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∆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sigB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mpl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1138702" y="4898030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1112866" y="7714481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516662" y="1676658"/>
            <a:ext cx="16642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itchFamily="34" charset="0"/>
                <a:cs typeface="Arial" pitchFamily="34" charset="0"/>
              </a:rPr>
              <a:t>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: SCVs after 7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170011" y="1060152"/>
            <a:ext cx="3979069" cy="2071688"/>
            <a:chOff x="170011" y="844128"/>
            <a:chExt cx="3979069" cy="2071688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011" y="844128"/>
              <a:ext cx="3979069" cy="20716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feld 26"/>
            <p:cNvSpPr txBox="1"/>
            <p:nvPr/>
          </p:nvSpPr>
          <p:spPr>
            <a:xfrm>
              <a:off x="2461112" y="224799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2477355" y="1383903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133668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Bildschirmpräsentation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3</cp:revision>
  <cp:lastPrinted>2015-02-05T15:03:15Z</cp:lastPrinted>
  <dcterms:created xsi:type="dcterms:W3CDTF">2014-11-04T10:41:58Z</dcterms:created>
  <dcterms:modified xsi:type="dcterms:W3CDTF">2015-04-13T07:31:36Z</dcterms:modified>
</cp:coreProperties>
</file>